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58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6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F17AD8-6B8C-4CFF-A0EE-A824AC91C6F1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7A8322-43BA-4CA2-B60A-59DCA64314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25646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presentative images of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57BL6 </a:t>
            </a:r>
            <a:r>
              <a:rPr lang="en-US" sz="120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Apc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n/+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ce acquired by in vivo imaging. One TA was injected at 8 weeks of age with 10^12 vg/mL of MyoRep-carrying AAV9, the contralateral leg was injected with PBS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is of photon emission from the region of interest over time (ROI on TA). Two-way ANOVA, Tukey’s post hoc test, *p≤0.05, N=4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ody weight loss (%) of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57BL6 </a:t>
            </a:r>
            <a:r>
              <a:rPr lang="en-US" sz="120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Apc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n/+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ce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plotted over time. 2way ANOVA followed by Tukey’s post hoc test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p≤0.05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N = 5.</a:t>
            </a:r>
            <a:r>
              <a:rPr lang="en-US" b="0" dirty="0"/>
              <a:t> </a:t>
            </a:r>
            <a:r>
              <a:rPr lang="en-US" b="1" dirty="0"/>
              <a:t>(D)</a:t>
            </a:r>
            <a:r>
              <a:rPr lang="en-US" b="0" dirty="0"/>
              <a:t> Luciferase Assay analysis ex-vivo of TA from male and female WT and ApcMin mice at 15 weeks of age. Total</a:t>
            </a:r>
            <a:r>
              <a:rPr lang="en-US" b="0" baseline="0" dirty="0"/>
              <a:t> proteins were used to normalize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e-way ANOVA, Tukey’s post hoc test, *p≤0.05, N=3. </a:t>
            </a:r>
            <a:r>
              <a:rPr lang="en-US" b="1" dirty="0"/>
              <a:t>(E)</a:t>
            </a:r>
            <a:r>
              <a:rPr lang="en-US" b="0" dirty="0"/>
              <a:t> Western blot for MuRF1 of TA from male and female</a:t>
            </a:r>
            <a:r>
              <a:rPr lang="en-US" b="0" baseline="0" dirty="0"/>
              <a:t> WT and ApcMin mice at 15 weeks of age</a:t>
            </a:r>
            <a:r>
              <a:rPr lang="en-US" b="0" dirty="0"/>
              <a:t>. Vinculin is used as loading control. </a:t>
            </a:r>
            <a:r>
              <a:rPr lang="en-US" b="1" dirty="0"/>
              <a:t>(F)</a:t>
            </a:r>
            <a:r>
              <a:rPr lang="en-US" b="0" dirty="0"/>
              <a:t> Quantification of western blot in E. N = 4-9. All data are reported as mean ± SEM.</a:t>
            </a:r>
            <a:endParaRPr lang="it-IT" dirty="0"/>
          </a:p>
          <a:p>
            <a:endParaRPr lang="it-IT" b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2A57DA-D4C7-4C49-B1E1-A7859D8BCAF1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40099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is of photon emission from the region of interest over time (ROI on TA) and representative images of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57BL6 MCG101 bearing-MyoRep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ce acquired by in vivo imaging. One-way ANOVA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unnett’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st hoc test vs day 0, *p≤0.05, ** p&lt;0.01, N = 5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alysis of photon emission from the region of interest over time (ROI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n whole mouse on dorsal view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representative images of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57BL6 MCG101 bearing-MyoRep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ce acquired by in vivo imaging. One-way ANOVA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unnett’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st hoc test vs day 0, ** p&lt;0.01, *** p&lt;0.001, N = 5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alysis of photon emission from the region of interest over time (ROI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n whole mouse on ventral view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representative images of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57BL6 MCG101 bearing-MyoRep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ce acquired by in vivo imaging. One-way ANOVA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unnett’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st hoc test vs day 0, N = 5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RF1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 expression measured by qPCR in TA and back muscle (BM) at 6 and 20 days post tumor inoculation. HK = housekeeping gene for normalization. Unpaired t test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p≤0.05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 = 3-4. </a:t>
            </a:r>
            <a:r>
              <a:rPr lang="en-US" b="0" dirty="0"/>
              <a:t>All data are reported as mean ± SEM.</a:t>
            </a:r>
            <a:endParaRPr lang="it-IT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it-IT" dirty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2A57DA-D4C7-4C49-B1E1-A7859D8BCAF1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79449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(A) </a:t>
            </a:r>
            <a:r>
              <a:rPr lang="en-US" b="0" dirty="0"/>
              <a:t>Gastrocnemius</a:t>
            </a:r>
            <a:r>
              <a:rPr lang="en-US" b="0" baseline="0" dirty="0"/>
              <a:t> (GAS) and tibialis anterior (TA) weight (% of non-</a:t>
            </a:r>
            <a:r>
              <a:rPr lang="en-US" b="0" baseline="0" dirty="0" err="1"/>
              <a:t>denervated</a:t>
            </a:r>
            <a:r>
              <a:rPr lang="en-US" b="0" baseline="0" dirty="0"/>
              <a:t> side) of </a:t>
            </a:r>
            <a:r>
              <a:rPr lang="en-US" b="0" baseline="0" dirty="0" err="1"/>
              <a:t>denervated</a:t>
            </a:r>
            <a:r>
              <a:rPr lang="en-US" b="0" baseline="0" dirty="0"/>
              <a:t> leg at different time points. One-way ANOVA test followed by </a:t>
            </a:r>
            <a:r>
              <a:rPr lang="en-US" b="0" baseline="0" dirty="0" err="1"/>
              <a:t>Dunnett’s</a:t>
            </a:r>
            <a:r>
              <a:rPr lang="en-US" b="0" baseline="0" dirty="0"/>
              <a:t> post hoc test. * p≤0.05. N = ?. </a:t>
            </a:r>
            <a:r>
              <a:rPr lang="en-US" b="1" dirty="0"/>
              <a:t>(B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tive images of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57BL6 MyoRep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ce acquired by in vivo imaging at different time points.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left tibialis anterior is </a:t>
            </a:r>
            <a:r>
              <a:rPr lang="en-US" sz="120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nervated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he right one is sham-operated </a:t>
            </a:r>
            <a:r>
              <a:rPr lang="en-US" b="1" baseline="0" dirty="0"/>
              <a:t>(C) </a:t>
            </a:r>
            <a:r>
              <a:rPr lang="en-US" b="0" baseline="0" dirty="0"/>
              <a:t>Analysis of photon emission from the region of interest (ROI, tibialis anterior, red circle). paired t test, * p≤0.05; ** p&lt;0.01. N = 4. </a:t>
            </a:r>
            <a:r>
              <a:rPr lang="en-US" b="0" dirty="0"/>
              <a:t> All data are reported as mean ± SEM.</a:t>
            </a:r>
            <a:endParaRPr lang="it-IT" dirty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2A57DA-D4C7-4C49-B1E1-A7859D8BCAF1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448527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800" b="1" dirty="0" err="1"/>
              <a:t>Supplementary</a:t>
            </a:r>
            <a:r>
              <a:rPr lang="it-IT" sz="800" b="1" dirty="0"/>
              <a:t> figure 3.</a:t>
            </a:r>
            <a:r>
              <a:rPr lang="en-US" sz="800" b="1" dirty="0"/>
              <a:t> </a:t>
            </a:r>
            <a:r>
              <a:rPr lang="en-US" sz="800" dirty="0"/>
              <a:t>The generation scheme of the MyoRep mouse (</a:t>
            </a:r>
            <a:r>
              <a:rPr lang="en-US" sz="800" b="1" dirty="0"/>
              <a:t>A</a:t>
            </a:r>
            <a:r>
              <a:rPr lang="en-US" sz="800" dirty="0"/>
              <a:t>). The stop sequence in Luc2 mouse is removed using the </a:t>
            </a:r>
            <a:r>
              <a:rPr lang="en-US" sz="800" dirty="0" err="1"/>
              <a:t>loxP</a:t>
            </a:r>
            <a:r>
              <a:rPr lang="en-US" sz="800" dirty="0"/>
              <a:t> system after crossing with the B6.Cg-Tg(ACTA1-cre)79Jme/J mouse. Compared to the Luc2 mouse, the MyoRep mouse shows a basal bioluminescence signal following the removal of the stop sequence (</a:t>
            </a:r>
            <a:r>
              <a:rPr lang="en-US" sz="800" b="1" dirty="0"/>
              <a:t>B</a:t>
            </a:r>
            <a:r>
              <a:rPr lang="en-US" sz="800" dirty="0"/>
              <a:t>).</a:t>
            </a:r>
            <a:endParaRPr lang="it-IT" sz="800" dirty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2A57DA-D4C7-4C49-B1E1-A7859D8BCAF1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42354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4746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8216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75250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7673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0317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0899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6139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8909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1326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4733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3584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8F22C5-6358-4C94-AE5A-AA8A61E0FC12}" type="datetimeFigureOut">
              <a:rPr lang="it-IT" smtClean="0"/>
              <a:t>05/12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44D5F-7937-40EE-8E8E-126C34D0B9E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61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31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12" Type="http://schemas.openxmlformats.org/officeDocument/2006/relationships/image" Target="../media/image3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Relationship Id="rId14" Type="http://schemas.openxmlformats.org/officeDocument/2006/relationships/image" Target="../media/image3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D518A93C-0D5C-DE40-8911-452F7E3931D6}"/>
              </a:ext>
            </a:extLst>
          </p:cNvPr>
          <p:cNvSpPr txBox="1"/>
          <p:nvPr/>
        </p:nvSpPr>
        <p:spPr>
          <a:xfrm>
            <a:off x="5448009" y="-31308"/>
            <a:ext cx="1438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data Figure 5</a:t>
            </a:r>
          </a:p>
        </p:txBody>
      </p:sp>
      <p:pic>
        <p:nvPicPr>
          <p:cNvPr id="33" name="Immagine 3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25" r="-430"/>
          <a:stretch/>
        </p:blipFill>
        <p:spPr>
          <a:xfrm>
            <a:off x="123377" y="644613"/>
            <a:ext cx="2066763" cy="167467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4" name="Immagine 3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0" r="-104"/>
          <a:stretch/>
        </p:blipFill>
        <p:spPr>
          <a:xfrm>
            <a:off x="2477870" y="680757"/>
            <a:ext cx="1972391" cy="161349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5" name="Immagine 3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4" r="-486"/>
          <a:stretch/>
        </p:blipFill>
        <p:spPr>
          <a:xfrm>
            <a:off x="4719117" y="608470"/>
            <a:ext cx="2021317" cy="168578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6" name="Immagine 3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7" r="1198"/>
          <a:stretch/>
        </p:blipFill>
        <p:spPr>
          <a:xfrm>
            <a:off x="145193" y="2925181"/>
            <a:ext cx="2066763" cy="161233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7" name="Immagine 36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8" r="790"/>
          <a:stretch/>
        </p:blipFill>
        <p:spPr>
          <a:xfrm>
            <a:off x="2480813" y="2925181"/>
            <a:ext cx="1991265" cy="161233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8" name="Immagine 37"/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7" r="231"/>
          <a:stretch/>
        </p:blipFill>
        <p:spPr>
          <a:xfrm>
            <a:off x="4740933" y="2925178"/>
            <a:ext cx="2040190" cy="160826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9" name="Immagine 38"/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" r="1036"/>
          <a:stretch/>
        </p:blipFill>
        <p:spPr>
          <a:xfrm>
            <a:off x="160065" y="5342600"/>
            <a:ext cx="2048948" cy="160180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0" name="Immagine 39"/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2" r="908"/>
          <a:stretch/>
        </p:blipFill>
        <p:spPr>
          <a:xfrm>
            <a:off x="2477870" y="5342603"/>
            <a:ext cx="1972391" cy="160180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1" name="Immagine 40"/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6" r="844"/>
          <a:stretch/>
        </p:blipFill>
        <p:spPr>
          <a:xfrm>
            <a:off x="4719117" y="5342603"/>
            <a:ext cx="2040190" cy="160180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2" name="Immagine 41"/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5" r="543"/>
          <a:stretch/>
        </p:blipFill>
        <p:spPr>
          <a:xfrm>
            <a:off x="141192" y="7896915"/>
            <a:ext cx="2066084" cy="160180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3" name="Immagine 42"/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6" r="565"/>
          <a:stretch/>
        </p:blipFill>
        <p:spPr>
          <a:xfrm>
            <a:off x="2449561" y="7896915"/>
            <a:ext cx="1991265" cy="160180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4" name="Immagine 43"/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2" r="911"/>
          <a:stretch/>
        </p:blipFill>
        <p:spPr>
          <a:xfrm>
            <a:off x="4683109" y="7886392"/>
            <a:ext cx="2057325" cy="161233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8" name="CasellaDiTesto 67"/>
          <p:cNvSpPr txBox="1"/>
          <p:nvPr/>
        </p:nvSpPr>
        <p:spPr>
          <a:xfrm>
            <a:off x="1011369" y="3983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69" name="CasellaDiTesto 68"/>
          <p:cNvSpPr txBox="1"/>
          <p:nvPr/>
        </p:nvSpPr>
        <p:spPr>
          <a:xfrm>
            <a:off x="3392554" y="3983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70" name="CasellaDiTesto 69"/>
          <p:cNvSpPr txBox="1"/>
          <p:nvPr/>
        </p:nvSpPr>
        <p:spPr>
          <a:xfrm>
            <a:off x="5610874" y="3622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76" name="CasellaDiTesto 75"/>
          <p:cNvSpPr txBox="1"/>
          <p:nvPr/>
        </p:nvSpPr>
        <p:spPr>
          <a:xfrm>
            <a:off x="3164927" y="152170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ales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CasellaDiTesto 80"/>
          <p:cNvSpPr txBox="1"/>
          <p:nvPr/>
        </p:nvSpPr>
        <p:spPr>
          <a:xfrm>
            <a:off x="928819" y="26427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82" name="CasellaDiTesto 81"/>
          <p:cNvSpPr txBox="1"/>
          <p:nvPr/>
        </p:nvSpPr>
        <p:spPr>
          <a:xfrm>
            <a:off x="3310004" y="26427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83" name="CasellaDiTesto 82"/>
          <p:cNvSpPr txBox="1"/>
          <p:nvPr/>
        </p:nvSpPr>
        <p:spPr>
          <a:xfrm>
            <a:off x="5528324" y="26066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84" name="CasellaDiTesto 83"/>
          <p:cNvSpPr txBox="1"/>
          <p:nvPr/>
        </p:nvSpPr>
        <p:spPr>
          <a:xfrm>
            <a:off x="3082377" y="2396554"/>
            <a:ext cx="8947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CasellaDiTesto 84"/>
          <p:cNvSpPr txBox="1"/>
          <p:nvPr/>
        </p:nvSpPr>
        <p:spPr>
          <a:xfrm>
            <a:off x="848504" y="50181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86" name="CasellaDiTesto 85"/>
          <p:cNvSpPr txBox="1"/>
          <p:nvPr/>
        </p:nvSpPr>
        <p:spPr>
          <a:xfrm>
            <a:off x="3229689" y="50181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87" name="CasellaDiTesto 86"/>
          <p:cNvSpPr txBox="1"/>
          <p:nvPr/>
        </p:nvSpPr>
        <p:spPr>
          <a:xfrm>
            <a:off x="5448009" y="49820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89" name="CasellaDiTesto 88"/>
          <p:cNvSpPr txBox="1"/>
          <p:nvPr/>
        </p:nvSpPr>
        <p:spPr>
          <a:xfrm>
            <a:off x="2870616" y="4813836"/>
            <a:ext cx="1043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it-IT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Min/+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ales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CasellaDiTesto 89"/>
          <p:cNvSpPr txBox="1"/>
          <p:nvPr/>
        </p:nvSpPr>
        <p:spPr>
          <a:xfrm>
            <a:off x="879922" y="758290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91" name="CasellaDiTesto 90"/>
          <p:cNvSpPr txBox="1"/>
          <p:nvPr/>
        </p:nvSpPr>
        <p:spPr>
          <a:xfrm>
            <a:off x="3261107" y="758290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92" name="CasellaDiTesto 91"/>
          <p:cNvSpPr txBox="1"/>
          <p:nvPr/>
        </p:nvSpPr>
        <p:spPr>
          <a:xfrm>
            <a:off x="5479427" y="75467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93" name="CasellaDiTesto 92"/>
          <p:cNvSpPr txBox="1"/>
          <p:nvPr/>
        </p:nvSpPr>
        <p:spPr>
          <a:xfrm>
            <a:off x="2902034" y="7378592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it-IT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Min/+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7938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0DE72F39-99CE-A44D-96C8-463409ECC2C2}"/>
              </a:ext>
            </a:extLst>
          </p:cNvPr>
          <p:cNvSpPr txBox="1"/>
          <p:nvPr/>
        </p:nvSpPr>
        <p:spPr>
          <a:xfrm>
            <a:off x="5423654" y="-5220"/>
            <a:ext cx="1438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data Figure 6</a:t>
            </a:r>
          </a:p>
        </p:txBody>
      </p:sp>
      <p:pic>
        <p:nvPicPr>
          <p:cNvPr id="24" name="Immagine 2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" t="-1" r="206" b="2278"/>
          <a:stretch/>
        </p:blipFill>
        <p:spPr>
          <a:xfrm>
            <a:off x="1174770" y="3942965"/>
            <a:ext cx="2200841" cy="102118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8" name="Immagine 2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" t="-1" r="-784" b="1111"/>
          <a:stretch/>
        </p:blipFill>
        <p:spPr>
          <a:xfrm>
            <a:off x="3582672" y="3900259"/>
            <a:ext cx="1863211" cy="115285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9" name="Immagine 2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3" r="527" b="2602"/>
          <a:stretch/>
        </p:blipFill>
        <p:spPr>
          <a:xfrm>
            <a:off x="1174770" y="5161392"/>
            <a:ext cx="2197417" cy="124502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0" name="Immagine 2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" r="1394" b="3696"/>
          <a:stretch/>
        </p:blipFill>
        <p:spPr>
          <a:xfrm>
            <a:off x="3542077" y="5227229"/>
            <a:ext cx="1988260" cy="117918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2" name="Immagine 1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6" t="-1" r="2328" b="1754"/>
          <a:stretch/>
        </p:blipFill>
        <p:spPr>
          <a:xfrm>
            <a:off x="1174284" y="644252"/>
            <a:ext cx="2048304" cy="107851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3" name="Immagine 1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82" r="1804" b="3581"/>
          <a:stretch/>
        </p:blipFill>
        <p:spPr>
          <a:xfrm>
            <a:off x="3319277" y="667554"/>
            <a:ext cx="2113307" cy="103545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" name="Immagine 1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0" t="-261" r="1328" b="-1049"/>
          <a:stretch/>
        </p:blipFill>
        <p:spPr>
          <a:xfrm>
            <a:off x="1171806" y="1846807"/>
            <a:ext cx="2050783" cy="105444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5" name="Immagine 1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0" r="1979" b="2097"/>
          <a:stretch/>
        </p:blipFill>
        <p:spPr>
          <a:xfrm>
            <a:off x="3319277" y="1846807"/>
            <a:ext cx="2104377" cy="107463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6" name="CasellaDiTesto 65"/>
          <p:cNvSpPr txBox="1"/>
          <p:nvPr/>
        </p:nvSpPr>
        <p:spPr>
          <a:xfrm>
            <a:off x="600904" y="1060397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</a:p>
        </p:txBody>
      </p:sp>
      <p:sp>
        <p:nvSpPr>
          <p:cNvPr id="67" name="CasellaDiTesto 66"/>
          <p:cNvSpPr txBox="1"/>
          <p:nvPr/>
        </p:nvSpPr>
        <p:spPr>
          <a:xfrm>
            <a:off x="5530337" y="103596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71" name="CasellaDiTesto 70"/>
          <p:cNvSpPr txBox="1"/>
          <p:nvPr/>
        </p:nvSpPr>
        <p:spPr>
          <a:xfrm>
            <a:off x="819920" y="23727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72" name="CasellaDiTesto 71"/>
          <p:cNvSpPr txBox="1"/>
          <p:nvPr/>
        </p:nvSpPr>
        <p:spPr>
          <a:xfrm>
            <a:off x="5485593" y="22610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3" name="CasellaDiTesto 72"/>
          <p:cNvSpPr txBox="1"/>
          <p:nvPr/>
        </p:nvSpPr>
        <p:spPr>
          <a:xfrm>
            <a:off x="2270514" y="3026153"/>
            <a:ext cx="21130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Images for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orsal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leg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iew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CasellaDiTesto 73"/>
          <p:cNvSpPr txBox="1"/>
          <p:nvPr/>
        </p:nvSpPr>
        <p:spPr>
          <a:xfrm>
            <a:off x="646037" y="4461051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</a:p>
        </p:txBody>
      </p:sp>
      <p:sp>
        <p:nvSpPr>
          <p:cNvPr id="75" name="CasellaDiTesto 74"/>
          <p:cNvSpPr txBox="1"/>
          <p:nvPr/>
        </p:nvSpPr>
        <p:spPr>
          <a:xfrm>
            <a:off x="5575470" y="443662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76" name="CasellaDiTesto 75"/>
          <p:cNvSpPr txBox="1"/>
          <p:nvPr/>
        </p:nvSpPr>
        <p:spPr>
          <a:xfrm>
            <a:off x="865053" y="57734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77" name="CasellaDiTesto 76"/>
          <p:cNvSpPr txBox="1"/>
          <p:nvPr/>
        </p:nvSpPr>
        <p:spPr>
          <a:xfrm>
            <a:off x="5530726" y="56616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8" name="CasellaDiTesto 77"/>
          <p:cNvSpPr txBox="1"/>
          <p:nvPr/>
        </p:nvSpPr>
        <p:spPr>
          <a:xfrm>
            <a:off x="2315647" y="6426807"/>
            <a:ext cx="15953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Images for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entral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view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50030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0DE72F39-99CE-A44D-96C8-463409ECC2C2}"/>
              </a:ext>
            </a:extLst>
          </p:cNvPr>
          <p:cNvSpPr txBox="1"/>
          <p:nvPr/>
        </p:nvSpPr>
        <p:spPr>
          <a:xfrm>
            <a:off x="5419786" y="0"/>
            <a:ext cx="1438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data Figure 7</a:t>
            </a:r>
          </a:p>
        </p:txBody>
      </p:sp>
      <p:grpSp>
        <p:nvGrpSpPr>
          <p:cNvPr id="5" name="Gruppo 4"/>
          <p:cNvGrpSpPr/>
          <p:nvPr/>
        </p:nvGrpSpPr>
        <p:grpSpPr>
          <a:xfrm>
            <a:off x="777751" y="892510"/>
            <a:ext cx="5153922" cy="6907720"/>
            <a:chOff x="1622483" y="2390384"/>
            <a:chExt cx="2577205" cy="3044333"/>
          </a:xfrm>
        </p:grpSpPr>
        <p:pic>
          <p:nvPicPr>
            <p:cNvPr id="20" name="Immagine 19">
              <a:extLst>
                <a:ext uri="{FF2B5EF4-FFF2-40B4-BE49-F238E27FC236}">
                  <a16:creationId xmlns:a16="http://schemas.microsoft.com/office/drawing/2014/main" id="{43F8DC51-D3AA-DA4D-ACE8-517D0914DA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7" t="1137" r="311" b="-2"/>
            <a:stretch/>
          </p:blipFill>
          <p:spPr>
            <a:xfrm>
              <a:off x="1704348" y="2393429"/>
              <a:ext cx="717524" cy="60124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22" name="Immagine 21">
              <a:extLst>
                <a:ext uri="{FF2B5EF4-FFF2-40B4-BE49-F238E27FC236}">
                  <a16:creationId xmlns:a16="http://schemas.microsoft.com/office/drawing/2014/main" id="{1998E233-95E0-C64C-980E-AB08F7BCC5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3" r="863"/>
            <a:stretch/>
          </p:blipFill>
          <p:spPr>
            <a:xfrm>
              <a:off x="2566045" y="2393429"/>
              <a:ext cx="654920" cy="60154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24" name="Immagine 23">
              <a:extLst>
                <a:ext uri="{FF2B5EF4-FFF2-40B4-BE49-F238E27FC236}">
                  <a16:creationId xmlns:a16="http://schemas.microsoft.com/office/drawing/2014/main" id="{5CA9BEF5-9585-5E47-9D52-27A46C2FB6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0" t="-141" r="292" b="-1"/>
            <a:stretch/>
          </p:blipFill>
          <p:spPr>
            <a:xfrm>
              <a:off x="3415829" y="2390384"/>
              <a:ext cx="664551" cy="604288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26" name="Immagine 25">
              <a:extLst>
                <a:ext uri="{FF2B5EF4-FFF2-40B4-BE49-F238E27FC236}">
                  <a16:creationId xmlns:a16="http://schemas.microsoft.com/office/drawing/2014/main" id="{3F901F03-29B9-1C49-929F-8F86FD29B6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6" t="-52" r="230" b="682"/>
            <a:stretch/>
          </p:blipFill>
          <p:spPr>
            <a:xfrm>
              <a:off x="2593575" y="3206735"/>
              <a:ext cx="621210" cy="60269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29" name="Immagine 28">
              <a:extLst>
                <a:ext uri="{FF2B5EF4-FFF2-40B4-BE49-F238E27FC236}">
                  <a16:creationId xmlns:a16="http://schemas.microsoft.com/office/drawing/2014/main" id="{7AC6FECB-8F75-554C-87B7-A0BFFB5E0E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9" t="-41" r="325" b="2045"/>
            <a:stretch/>
          </p:blipFill>
          <p:spPr>
            <a:xfrm>
              <a:off x="1685087" y="3205215"/>
              <a:ext cx="736785" cy="60421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9" name="Immagine 8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3" t="1" r="564" b="1167"/>
            <a:stretch/>
          </p:blipFill>
          <p:spPr>
            <a:xfrm>
              <a:off x="3425005" y="3206735"/>
              <a:ext cx="727156" cy="60269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46" name="Immagine 4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974" r="-3972"/>
            <a:stretch/>
          </p:blipFill>
          <p:spPr>
            <a:xfrm>
              <a:off x="1622483" y="3982122"/>
              <a:ext cx="799389" cy="60269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48" name="Immagine 47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8" r="605"/>
            <a:stretch/>
          </p:blipFill>
          <p:spPr>
            <a:xfrm>
              <a:off x="2531823" y="3982122"/>
              <a:ext cx="799389" cy="60469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49" name="Immagine 48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0" r="1039"/>
            <a:stretch/>
          </p:blipFill>
          <p:spPr>
            <a:xfrm>
              <a:off x="3448455" y="3987939"/>
              <a:ext cx="751233" cy="61157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51" name="Immagine 50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461" r="-378"/>
            <a:stretch/>
          </p:blipFill>
          <p:spPr>
            <a:xfrm>
              <a:off x="1656193" y="4825753"/>
              <a:ext cx="765679" cy="608964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53" name="Immagine 52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6" r="2092"/>
            <a:stretch/>
          </p:blipFill>
          <p:spPr>
            <a:xfrm>
              <a:off x="2646086" y="4829435"/>
              <a:ext cx="645288" cy="605282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55" name="Immagine 54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1" r="386"/>
            <a:stretch/>
          </p:blipFill>
          <p:spPr>
            <a:xfrm>
              <a:off x="3515588" y="4829853"/>
              <a:ext cx="640475" cy="604864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  <p:sp>
        <p:nvSpPr>
          <p:cNvPr id="84" name="CasellaDiTesto 83"/>
          <p:cNvSpPr txBox="1"/>
          <p:nvPr/>
        </p:nvSpPr>
        <p:spPr>
          <a:xfrm>
            <a:off x="1396669" y="2290795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</a:p>
        </p:txBody>
      </p:sp>
      <p:sp>
        <p:nvSpPr>
          <p:cNvPr id="85" name="CasellaDiTesto 84"/>
          <p:cNvSpPr txBox="1"/>
          <p:nvPr/>
        </p:nvSpPr>
        <p:spPr>
          <a:xfrm>
            <a:off x="3133320" y="22907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6" name="CasellaDiTesto 85"/>
          <p:cNvSpPr txBox="1"/>
          <p:nvPr/>
        </p:nvSpPr>
        <p:spPr>
          <a:xfrm>
            <a:off x="4900992" y="22907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7" name="CasellaDiTesto 86"/>
          <p:cNvSpPr txBox="1"/>
          <p:nvPr/>
        </p:nvSpPr>
        <p:spPr>
          <a:xfrm>
            <a:off x="1512063" y="409652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8" name="CasellaDiTesto 87"/>
          <p:cNvSpPr txBox="1"/>
          <p:nvPr/>
        </p:nvSpPr>
        <p:spPr>
          <a:xfrm>
            <a:off x="3214792" y="41210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9" name="CasellaDiTesto 88"/>
          <p:cNvSpPr txBox="1"/>
          <p:nvPr/>
        </p:nvSpPr>
        <p:spPr>
          <a:xfrm>
            <a:off x="4981942" y="41210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90" name="CasellaDiTesto 89"/>
          <p:cNvSpPr txBox="1"/>
          <p:nvPr/>
        </p:nvSpPr>
        <p:spPr>
          <a:xfrm>
            <a:off x="1414199" y="587176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91" name="CasellaDiTesto 90"/>
          <p:cNvSpPr txBox="1"/>
          <p:nvPr/>
        </p:nvSpPr>
        <p:spPr>
          <a:xfrm>
            <a:off x="3214792" y="587176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92" name="CasellaDiTesto 91"/>
          <p:cNvSpPr txBox="1"/>
          <p:nvPr/>
        </p:nvSpPr>
        <p:spPr>
          <a:xfrm>
            <a:off x="5041152" y="59051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93" name="CasellaDiTesto 92"/>
          <p:cNvSpPr txBox="1"/>
          <p:nvPr/>
        </p:nvSpPr>
        <p:spPr>
          <a:xfrm>
            <a:off x="1414199" y="78002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94" name="CasellaDiTesto 93"/>
          <p:cNvSpPr txBox="1"/>
          <p:nvPr/>
        </p:nvSpPr>
        <p:spPr>
          <a:xfrm>
            <a:off x="3319554" y="78002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</a:p>
        </p:txBody>
      </p:sp>
      <p:sp>
        <p:nvSpPr>
          <p:cNvPr id="95" name="CasellaDiTesto 94"/>
          <p:cNvSpPr txBox="1"/>
          <p:nvPr/>
        </p:nvSpPr>
        <p:spPr>
          <a:xfrm>
            <a:off x="5070470" y="78002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</p:spTree>
    <p:extLst>
      <p:ext uri="{BB962C8B-B14F-4D97-AF65-F5344CB8AC3E}">
        <p14:creationId xmlns:p14="http://schemas.microsoft.com/office/powerpoint/2010/main" val="40557074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uppo 33"/>
          <p:cNvGrpSpPr/>
          <p:nvPr/>
        </p:nvGrpSpPr>
        <p:grpSpPr>
          <a:xfrm>
            <a:off x="1765300" y="2184379"/>
            <a:ext cx="2921000" cy="2012398"/>
            <a:chOff x="1765300" y="2184380"/>
            <a:chExt cx="1098550" cy="846552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 rotWithShape="1">
            <a:blip r:embed="rId3"/>
            <a:srcRect l="1952" t="3354" r="1210" b="3397"/>
            <a:stretch/>
          </p:blipFill>
          <p:spPr>
            <a:xfrm>
              <a:off x="1765300" y="2184380"/>
              <a:ext cx="1098550" cy="71122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71" name="TextBox 59">
              <a:extLst>
                <a:ext uri="{FF2B5EF4-FFF2-40B4-BE49-F238E27FC236}">
                  <a16:creationId xmlns:a16="http://schemas.microsoft.com/office/drawing/2014/main" id="{A3D11771-BF31-49F4-A28F-4498773AFF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69231" y="2914407"/>
              <a:ext cx="579244" cy="116525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45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39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3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1279525" fontAlgn="base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1279525" fontAlgn="base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1279525" fontAlgn="base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1279525" fontAlgn="base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  <a:defRPr/>
              </a:pPr>
              <a:r>
                <a:rPr lang="it-IT" alt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UC2</a:t>
              </a:r>
              <a:endParaRPr lang="it-IT" alt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59">
              <a:extLst>
                <a:ext uri="{FF2B5EF4-FFF2-40B4-BE49-F238E27FC236}">
                  <a16:creationId xmlns:a16="http://schemas.microsoft.com/office/drawing/2014/main" id="{A3D11771-BF31-49F4-A28F-4498773AFF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5300" y="2914407"/>
              <a:ext cx="579244" cy="116525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45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39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3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1279525" fontAlgn="base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1279525" fontAlgn="base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1279525" fontAlgn="base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1279525" fontAlgn="base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8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  <a:defRPr/>
              </a:pPr>
              <a:r>
                <a:rPr lang="it-IT" alt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yoRep</a:t>
              </a:r>
              <a:endParaRPr lang="it-IT" alt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E734C497-BE48-084E-B65F-93AB1DCA40AE}"/>
              </a:ext>
            </a:extLst>
          </p:cNvPr>
          <p:cNvSpPr txBox="1"/>
          <p:nvPr/>
        </p:nvSpPr>
        <p:spPr>
          <a:xfrm>
            <a:off x="4954311" y="83543"/>
            <a:ext cx="1923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Figure S5</a:t>
            </a:r>
          </a:p>
        </p:txBody>
      </p:sp>
    </p:spTree>
    <p:extLst>
      <p:ext uri="{BB962C8B-B14F-4D97-AF65-F5344CB8AC3E}">
        <p14:creationId xmlns:p14="http://schemas.microsoft.com/office/powerpoint/2010/main" val="34330944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706</Words>
  <Application>Microsoft Macintosh PowerPoint</Application>
  <PresentationFormat>A4 (21x29,7 cm)</PresentationFormat>
  <Paragraphs>52</Paragraphs>
  <Slides>4</Slides>
  <Notes>4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Re Cecconi</dc:creator>
  <cp:lastModifiedBy>Rosanna Piccirillo</cp:lastModifiedBy>
  <cp:revision>8</cp:revision>
  <dcterms:created xsi:type="dcterms:W3CDTF">2025-11-25T14:23:15Z</dcterms:created>
  <dcterms:modified xsi:type="dcterms:W3CDTF">2025-12-05T13:14:38Z</dcterms:modified>
</cp:coreProperties>
</file>